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345A3-C06F-4380-BD8B-2718E625FA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E94C8B-1E63-4871-BC0F-3BE0287C96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D706BC-884F-40CA-BADF-FFF2FD49C7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414261-B84E-4842-B0CC-D1EB858A513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A3F600-BFEB-4ECB-8520-C283CA86B4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6D2E9-A9A1-4C6C-BD72-4B53A8451A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A8033-B10F-41E6-B0B2-1761265CC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ADF39-E498-4BCC-9B34-C0C6983284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AC34D9-8712-4AAB-A67F-C5B640E9E2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2CC9BF-B9F2-4BCE-A1BC-92BFDEF470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60702C-AA81-493A-AFC6-167D112862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2A425B-830D-4169-AC19-3DC3E7CABA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178531-F6A0-4BAF-9AFC-F6BE4B959F3C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599840" y="1265400"/>
            <a:ext cx="5448240" cy="1866600"/>
            <a:chOff x="1599840" y="1265400"/>
            <a:chExt cx="5448240" cy="1866600"/>
          </a:xfrm>
        </p:grpSpPr>
        <p:sp>
          <p:nvSpPr>
            <p:cNvPr id="42" name=""/>
            <p:cNvSpPr/>
            <p:nvPr/>
          </p:nvSpPr>
          <p:spPr>
            <a:xfrm>
              <a:off x="2884320" y="2201760"/>
              <a:ext cx="367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599840" y="1960560"/>
              <a:ext cx="13694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DP-Glucos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ehydrogenase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flipH="1">
              <a:off x="5871960" y="1846440"/>
              <a:ext cx="43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H="1">
              <a:off x="5871960" y="2128680"/>
              <a:ext cx="43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flipH="1">
              <a:off x="5871960" y="2440080"/>
              <a:ext cx="43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256080" y="17035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1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256080" y="198612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256080" y="2316240"/>
              <a:ext cx="792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" descr=""/>
            <p:cNvPicPr/>
            <p:nvPr/>
          </p:nvPicPr>
          <p:blipFill>
            <a:blip r:embed="rId1"/>
            <a:stretch/>
          </p:blipFill>
          <p:spPr>
            <a:xfrm>
              <a:off x="3566880" y="1481040"/>
              <a:ext cx="2233080" cy="1428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2">
              <a:lum bright="14000"/>
            </a:blip>
            <a:stretch/>
          </p:blipFill>
          <p:spPr>
            <a:xfrm>
              <a:off x="3279600" y="1481040"/>
              <a:ext cx="2592000" cy="165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"/>
            <p:cNvSpPr/>
            <p:nvPr/>
          </p:nvSpPr>
          <p:spPr>
            <a:xfrm>
              <a:off x="5459040" y="1265400"/>
              <a:ext cx="36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846320" y="1265400"/>
              <a:ext cx="426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547880" y="1265400"/>
              <a:ext cx="426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E1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284360" y="1265400"/>
              <a:ext cx="36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989160" y="1265400"/>
              <a:ext cx="36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730320" y="1265400"/>
              <a:ext cx="36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417480" y="1265400"/>
              <a:ext cx="360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U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"/>
          <p:cNvSpPr/>
          <p:nvPr/>
        </p:nvSpPr>
        <p:spPr>
          <a:xfrm>
            <a:off x="1012680" y="3578400"/>
            <a:ext cx="74059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 u="sng">
                <a:solidFill>
                  <a:srgbClr val="000000"/>
                </a:solidFill>
                <a:uFillTx/>
                <a:latin typeface="Times New Roman"/>
              </a:rPr>
              <a:t>Supplementary Figure 1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:  Expression and purification of human UDP-glucose dehydrogenase. The protein was expressed in </a:t>
            </a:r>
            <a:r>
              <a:rPr b="0" i="1" lang="en-GB" sz="1200" spc="-1" strike="noStrike">
                <a:solidFill>
                  <a:srgbClr val="000000"/>
                </a:solidFill>
                <a:latin typeface="Times New Roman"/>
              </a:rPr>
              <a:t>E. coli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 Rosetta(DE3) and purified using a nickel-agarose column (see Materials &amp; Methods).  U, extract from cells immediately prior to induction; I, extract from cells at the end of the period of induction prior to harvesting; S, the supernatant remaining after sonication and centrifugation of the cells; F, the material passing through the column; E1 and E2, the first and second elutions respectively; M, molecular mass markers.  The masses of key markers (in kDa) are shown on the right of the gel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19T10:41:37Z</dcterms:created>
  <dc:creator>Thomas</dc:creator>
  <dc:description/>
  <dc:language>en-US</dc:language>
  <cp:lastModifiedBy>David J Timson</cp:lastModifiedBy>
  <dcterms:modified xsi:type="dcterms:W3CDTF">2011-02-15T10:12:21Z</dcterms:modified>
  <cp:revision>11</cp:revision>
  <dc:subject/>
  <dc:title>Slide 1</dc:title>
</cp:coreProperties>
</file>